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2.xml" ContentType="application/vnd.openxmlformats-officedocument.presentationml.notesSl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6" r:id="rId2"/>
    <p:sldId id="257" r:id="rId3"/>
  </p:sldIdLst>
  <p:sldSz cx="12192000" cy="6858000"/>
  <p:notesSz cx="6858000" cy="9144000"/>
  <p:defaultTextStyle>
    <a:defPPr>
      <a:defRPr lang="he-I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4" autoAdjust="0"/>
    <p:restoredTop sz="82722" autoAdjust="0"/>
  </p:normalViewPr>
  <p:slideViewPr>
    <p:cSldViewPr snapToGrid="0">
      <p:cViewPr varScale="1">
        <p:scale>
          <a:sx n="69" d="100"/>
          <a:sy n="69" d="100"/>
        </p:scale>
        <p:origin x="1234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raya\Documents\&#1512;&#1508;&#1493;&#1488;&#1492;\&#1506;&#1489;&#1493;&#1491;&#1514;%20&#1490;&#1502;&#1512;\JPGN\&#1502;&#1488;&#1490;&#1512;%20&#1505;&#1493;&#1508;&#1497;\&#1490;&#1512;&#1508;&#1497;&#1501;%20&#1493;&#1496;&#1497;&#1508;&#1493;&#1500;&#1497;&#1501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raya\Documents\&#1512;&#1508;&#1493;&#1488;&#1492;\&#1506;&#1489;&#1493;&#1491;&#1514;%20&#1490;&#1502;&#1512;\JPGN\&#1502;&#1488;&#1490;&#1512;%20&#1505;&#1493;&#1508;&#1497;\&#1490;&#1512;&#1508;&#1497;&#1501;%20&#1493;&#1496;&#1497;&#1508;&#1493;&#1500;&#1497;&#1501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800" b="1"/>
              <a:t>Annual Incidence of EoE Diagnosis</a:t>
            </a:r>
          </a:p>
        </c:rich>
      </c:tx>
      <c:layout>
        <c:manualLayout>
          <c:xMode val="edge"/>
          <c:yMode val="edge"/>
          <c:x val="0.26183330902538959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he-IL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0"/>
            <c:trendlineLbl>
              <c:layout>
                <c:manualLayout>
                  <c:x val="8.2768222518435908E-3"/>
                  <c:y val="0.28843590168505207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2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cat>
            <c:numRef>
              <c:f>'גרף אבחנות לפי שנים'!$G$2:$G$16</c:f>
              <c:numCache>
                <c:formatCode>General</c:formatCode>
                <c:ptCount val="15"/>
                <c:pt idx="0">
                  <c:v>2009</c:v>
                </c:pt>
                <c:pt idx="1">
                  <c:v>2010</c:v>
                </c:pt>
                <c:pt idx="2">
                  <c:v>2011</c:v>
                </c:pt>
                <c:pt idx="3">
                  <c:v>2012</c:v>
                </c:pt>
                <c:pt idx="4">
                  <c:v>2013</c:v>
                </c:pt>
                <c:pt idx="5">
                  <c:v>2014</c:v>
                </c:pt>
                <c:pt idx="6">
                  <c:v>2015</c:v>
                </c:pt>
                <c:pt idx="7">
                  <c:v>2016</c:v>
                </c:pt>
                <c:pt idx="8">
                  <c:v>2017</c:v>
                </c:pt>
                <c:pt idx="9">
                  <c:v>2018</c:v>
                </c:pt>
                <c:pt idx="10">
                  <c:v>2019</c:v>
                </c:pt>
                <c:pt idx="11">
                  <c:v>2020</c:v>
                </c:pt>
                <c:pt idx="12">
                  <c:v>2021</c:v>
                </c:pt>
                <c:pt idx="13">
                  <c:v>2022</c:v>
                </c:pt>
                <c:pt idx="14">
                  <c:v>2023</c:v>
                </c:pt>
              </c:numCache>
            </c:numRef>
          </c:cat>
          <c:val>
            <c:numRef>
              <c:f>'גרף אבחנות לפי שנים'!$H$2:$H$16</c:f>
              <c:numCache>
                <c:formatCode>General</c:formatCode>
                <c:ptCount val="15"/>
                <c:pt idx="0">
                  <c:v>1</c:v>
                </c:pt>
                <c:pt idx="1">
                  <c:v>1</c:v>
                </c:pt>
                <c:pt idx="2">
                  <c:v>3</c:v>
                </c:pt>
                <c:pt idx="3">
                  <c:v>3</c:v>
                </c:pt>
                <c:pt idx="4">
                  <c:v>5</c:v>
                </c:pt>
                <c:pt idx="5">
                  <c:v>4</c:v>
                </c:pt>
                <c:pt idx="6">
                  <c:v>7</c:v>
                </c:pt>
                <c:pt idx="7">
                  <c:v>10</c:v>
                </c:pt>
                <c:pt idx="8">
                  <c:v>7</c:v>
                </c:pt>
                <c:pt idx="9">
                  <c:v>5</c:v>
                </c:pt>
                <c:pt idx="10">
                  <c:v>14</c:v>
                </c:pt>
                <c:pt idx="11">
                  <c:v>11</c:v>
                </c:pt>
                <c:pt idx="12">
                  <c:v>13</c:v>
                </c:pt>
                <c:pt idx="13">
                  <c:v>17</c:v>
                </c:pt>
                <c:pt idx="14">
                  <c:v>1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467-4753-8453-AE0FBC0DFF5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30015551"/>
        <c:axId val="730017471"/>
      </c:lineChart>
      <c:catAx>
        <c:axId val="73001555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 b="1"/>
                  <a:t>Year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he-IL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he-IL"/>
          </a:p>
        </c:txPr>
        <c:crossAx val="730017471"/>
        <c:crosses val="autoZero"/>
        <c:auto val="1"/>
        <c:lblAlgn val="ctr"/>
        <c:lblOffset val="100"/>
        <c:noMultiLvlLbl val="0"/>
      </c:catAx>
      <c:valAx>
        <c:axId val="730017471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 b="1"/>
                  <a:t>Number of New EoE Diagnoses</a:t>
                </a:r>
              </a:p>
            </c:rich>
          </c:tx>
          <c:layout>
            <c:manualLayout>
              <c:xMode val="edge"/>
              <c:yMode val="edge"/>
              <c:x val="1.9387526257122176E-2"/>
              <c:y val="8.8895070181444727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he-IL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he-IL"/>
          </a:p>
        </c:txPr>
        <c:crossAx val="73001555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zero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he-IL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0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2000" b="1" dirty="0"/>
              <a:t>Trends in Treatment Strategies Over the Past Decade</a:t>
            </a:r>
          </a:p>
        </c:rich>
      </c:tx>
      <c:layout>
        <c:manualLayout>
          <c:xMode val="edge"/>
          <c:yMode val="edge"/>
          <c:x val="0.16182611122417123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0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he-IL"/>
        </a:p>
      </c:txPr>
    </c:title>
    <c:autoTitleDeleted val="0"/>
    <c:plotArea>
      <c:layout/>
      <c:lineChart>
        <c:grouping val="standard"/>
        <c:varyColors val="0"/>
        <c:ser>
          <c:idx val="1"/>
          <c:order val="1"/>
          <c:tx>
            <c:strRef>
              <c:f>Sheet3!$C$1</c:f>
              <c:strCache>
                <c:ptCount val="1"/>
                <c:pt idx="0">
                  <c:v>PPI*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numRef>
              <c:f>Sheet3!$A$2:$A$11</c:f>
              <c:numCache>
                <c:formatCode>General</c:formatCode>
                <c:ptCount val="10"/>
                <c:pt idx="0">
                  <c:v>2015</c:v>
                </c:pt>
                <c:pt idx="1">
                  <c:v>2016</c:v>
                </c:pt>
                <c:pt idx="2">
                  <c:v>2017</c:v>
                </c:pt>
                <c:pt idx="3">
                  <c:v>2018</c:v>
                </c:pt>
                <c:pt idx="4">
                  <c:v>2019</c:v>
                </c:pt>
                <c:pt idx="5">
                  <c:v>2020</c:v>
                </c:pt>
                <c:pt idx="6">
                  <c:v>2021</c:v>
                </c:pt>
                <c:pt idx="7">
                  <c:v>2022</c:v>
                </c:pt>
                <c:pt idx="8">
                  <c:v>2023</c:v>
                </c:pt>
                <c:pt idx="9">
                  <c:v>2024</c:v>
                </c:pt>
              </c:numCache>
            </c:numRef>
          </c:cat>
          <c:val>
            <c:numRef>
              <c:f>Sheet3!$B$2:$B$11</c:f>
              <c:numCache>
                <c:formatCode>0</c:formatCode>
                <c:ptCount val="10"/>
                <c:pt idx="0">
                  <c:v>19.230769230769234</c:v>
                </c:pt>
                <c:pt idx="1">
                  <c:v>33.333333333333329</c:v>
                </c:pt>
                <c:pt idx="2">
                  <c:v>42.857142857142854</c:v>
                </c:pt>
                <c:pt idx="3">
                  <c:v>48.837209302325576</c:v>
                </c:pt>
                <c:pt idx="4">
                  <c:v>47.727272727272727</c:v>
                </c:pt>
                <c:pt idx="5">
                  <c:v>31.03448275862069</c:v>
                </c:pt>
                <c:pt idx="6">
                  <c:v>30.434782608695656</c:v>
                </c:pt>
                <c:pt idx="7">
                  <c:v>26</c:v>
                </c:pt>
                <c:pt idx="8">
                  <c:v>20.224719101123593</c:v>
                </c:pt>
                <c:pt idx="9">
                  <c:v>18.86792452830188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FAD-4A0F-9656-AA90D53181ED}"/>
            </c:ext>
          </c:extLst>
        </c:ser>
        <c:ser>
          <c:idx val="2"/>
          <c:order val="2"/>
          <c:tx>
            <c:strRef>
              <c:f>Sheet3!$E$1</c:f>
              <c:strCache>
                <c:ptCount val="1"/>
                <c:pt idx="0">
                  <c:v>Elimination Diet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numRef>
              <c:f>Sheet3!$A$2:$A$11</c:f>
              <c:numCache>
                <c:formatCode>General</c:formatCode>
                <c:ptCount val="10"/>
                <c:pt idx="0">
                  <c:v>2015</c:v>
                </c:pt>
                <c:pt idx="1">
                  <c:v>2016</c:v>
                </c:pt>
                <c:pt idx="2">
                  <c:v>2017</c:v>
                </c:pt>
                <c:pt idx="3">
                  <c:v>2018</c:v>
                </c:pt>
                <c:pt idx="4">
                  <c:v>2019</c:v>
                </c:pt>
                <c:pt idx="5">
                  <c:v>2020</c:v>
                </c:pt>
                <c:pt idx="6">
                  <c:v>2021</c:v>
                </c:pt>
                <c:pt idx="7">
                  <c:v>2022</c:v>
                </c:pt>
                <c:pt idx="8">
                  <c:v>2023</c:v>
                </c:pt>
                <c:pt idx="9">
                  <c:v>2024</c:v>
                </c:pt>
              </c:numCache>
            </c:numRef>
          </c:cat>
          <c:val>
            <c:numRef>
              <c:f>Sheet3!$D$2:$D$11</c:f>
              <c:numCache>
                <c:formatCode>0</c:formatCode>
                <c:ptCount val="10"/>
                <c:pt idx="0">
                  <c:v>61.53846153846154</c:v>
                </c:pt>
                <c:pt idx="1">
                  <c:v>51.515151515151516</c:v>
                </c:pt>
                <c:pt idx="2">
                  <c:v>45.714285714285715</c:v>
                </c:pt>
                <c:pt idx="3">
                  <c:v>32.558139534883722</c:v>
                </c:pt>
                <c:pt idx="4">
                  <c:v>38.636363636363633</c:v>
                </c:pt>
                <c:pt idx="5">
                  <c:v>43.103448275862064</c:v>
                </c:pt>
                <c:pt idx="6">
                  <c:v>43.478260869565219</c:v>
                </c:pt>
                <c:pt idx="7">
                  <c:v>50</c:v>
                </c:pt>
                <c:pt idx="8">
                  <c:v>52.80898876404494</c:v>
                </c:pt>
                <c:pt idx="9">
                  <c:v>49.0566037735849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CFAD-4A0F-9656-AA90D53181ED}"/>
            </c:ext>
          </c:extLst>
        </c:ser>
        <c:ser>
          <c:idx val="3"/>
          <c:order val="3"/>
          <c:tx>
            <c:strRef>
              <c:f>Sheet3!$G$1</c:f>
              <c:strCache>
                <c:ptCount val="1"/>
                <c:pt idx="0">
                  <c:v>TCS†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numRef>
              <c:f>Sheet3!$A$2:$A$11</c:f>
              <c:numCache>
                <c:formatCode>General</c:formatCode>
                <c:ptCount val="10"/>
                <c:pt idx="0">
                  <c:v>2015</c:v>
                </c:pt>
                <c:pt idx="1">
                  <c:v>2016</c:v>
                </c:pt>
                <c:pt idx="2">
                  <c:v>2017</c:v>
                </c:pt>
                <c:pt idx="3">
                  <c:v>2018</c:v>
                </c:pt>
                <c:pt idx="4">
                  <c:v>2019</c:v>
                </c:pt>
                <c:pt idx="5">
                  <c:v>2020</c:v>
                </c:pt>
                <c:pt idx="6">
                  <c:v>2021</c:v>
                </c:pt>
                <c:pt idx="7">
                  <c:v>2022</c:v>
                </c:pt>
                <c:pt idx="8">
                  <c:v>2023</c:v>
                </c:pt>
                <c:pt idx="9">
                  <c:v>2024</c:v>
                </c:pt>
              </c:numCache>
            </c:numRef>
          </c:cat>
          <c:val>
            <c:numRef>
              <c:f>Sheet3!$F$2:$F$11</c:f>
              <c:numCache>
                <c:formatCode>0</c:formatCode>
                <c:ptCount val="10"/>
                <c:pt idx="0">
                  <c:v>19.230769230769234</c:v>
                </c:pt>
                <c:pt idx="1">
                  <c:v>15.151515151515152</c:v>
                </c:pt>
                <c:pt idx="2">
                  <c:v>11.428571428571429</c:v>
                </c:pt>
                <c:pt idx="3">
                  <c:v>18.604651162790699</c:v>
                </c:pt>
                <c:pt idx="4">
                  <c:v>9.0909090909090917</c:v>
                </c:pt>
                <c:pt idx="5">
                  <c:v>25.862068965517242</c:v>
                </c:pt>
                <c:pt idx="6">
                  <c:v>21.739130434782609</c:v>
                </c:pt>
                <c:pt idx="7">
                  <c:v>22</c:v>
                </c:pt>
                <c:pt idx="8">
                  <c:v>21.348314606741571</c:v>
                </c:pt>
                <c:pt idx="9">
                  <c:v>9.43396226415094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CFAD-4A0F-9656-AA90D53181ED}"/>
            </c:ext>
          </c:extLst>
        </c:ser>
        <c:ser>
          <c:idx val="4"/>
          <c:order val="4"/>
          <c:tx>
            <c:strRef>
              <c:f>Sheet3!$H$1</c:f>
              <c:strCache>
                <c:ptCount val="1"/>
                <c:pt idx="0">
                  <c:v>SCS‡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cat>
            <c:numRef>
              <c:f>Sheet3!$A$2:$A$11</c:f>
              <c:numCache>
                <c:formatCode>General</c:formatCode>
                <c:ptCount val="10"/>
                <c:pt idx="0">
                  <c:v>2015</c:v>
                </c:pt>
                <c:pt idx="1">
                  <c:v>2016</c:v>
                </c:pt>
                <c:pt idx="2">
                  <c:v>2017</c:v>
                </c:pt>
                <c:pt idx="3">
                  <c:v>2018</c:v>
                </c:pt>
                <c:pt idx="4">
                  <c:v>2019</c:v>
                </c:pt>
                <c:pt idx="5">
                  <c:v>2020</c:v>
                </c:pt>
                <c:pt idx="6">
                  <c:v>2021</c:v>
                </c:pt>
                <c:pt idx="7">
                  <c:v>2022</c:v>
                </c:pt>
                <c:pt idx="8">
                  <c:v>2023</c:v>
                </c:pt>
                <c:pt idx="9">
                  <c:v>2024</c:v>
                </c:pt>
              </c:numCache>
            </c:numRef>
          </c:cat>
          <c:val>
            <c:numRef>
              <c:f>Sheet3!$H$2:$H$11</c:f>
              <c:numCache>
                <c:formatCode>0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4.5454545454545459</c:v>
                </c:pt>
                <c:pt idx="5">
                  <c:v>0</c:v>
                </c:pt>
                <c:pt idx="6">
                  <c:v>2.1739130434782608</c:v>
                </c:pt>
                <c:pt idx="7">
                  <c:v>2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CFAD-4A0F-9656-AA90D53181ED}"/>
            </c:ext>
          </c:extLst>
        </c:ser>
        <c:ser>
          <c:idx val="5"/>
          <c:order val="5"/>
          <c:tx>
            <c:strRef>
              <c:f>Sheet3!$J$1</c:f>
              <c:strCache>
                <c:ptCount val="1"/>
                <c:pt idx="0">
                  <c:v>Biologic</c:v>
                </c:pt>
              </c:strCache>
            </c:strRef>
          </c:tx>
          <c:spPr>
            <a:ln w="28575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cat>
            <c:numRef>
              <c:f>Sheet3!$A$2:$A$11</c:f>
              <c:numCache>
                <c:formatCode>General</c:formatCode>
                <c:ptCount val="10"/>
                <c:pt idx="0">
                  <c:v>2015</c:v>
                </c:pt>
                <c:pt idx="1">
                  <c:v>2016</c:v>
                </c:pt>
                <c:pt idx="2">
                  <c:v>2017</c:v>
                </c:pt>
                <c:pt idx="3">
                  <c:v>2018</c:v>
                </c:pt>
                <c:pt idx="4">
                  <c:v>2019</c:v>
                </c:pt>
                <c:pt idx="5">
                  <c:v>2020</c:v>
                </c:pt>
                <c:pt idx="6">
                  <c:v>2021</c:v>
                </c:pt>
                <c:pt idx="7">
                  <c:v>2022</c:v>
                </c:pt>
                <c:pt idx="8">
                  <c:v>2023</c:v>
                </c:pt>
                <c:pt idx="9">
                  <c:v>2024</c:v>
                </c:pt>
              </c:numCache>
            </c:numRef>
          </c:cat>
          <c:val>
            <c:numRef>
              <c:f>Sheet3!$J$2:$J$11</c:f>
              <c:numCache>
                <c:formatCode>0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2.1739130434782608</c:v>
                </c:pt>
                <c:pt idx="7">
                  <c:v>0</c:v>
                </c:pt>
                <c:pt idx="8">
                  <c:v>5.6179775280898872</c:v>
                </c:pt>
                <c:pt idx="9">
                  <c:v>22.64150943396226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CFAD-4A0F-9656-AA90D53181E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963062447"/>
        <c:axId val="1963042287"/>
        <c:extLst>
          <c:ext xmlns:c15="http://schemas.microsoft.com/office/drawing/2012/chart" uri="{02D57815-91ED-43cb-92C2-25804820EDAC}">
            <c15:filteredLineSeries>
              <c15:ser>
                <c:idx val="0"/>
                <c:order val="0"/>
                <c:tx>
                  <c:strRef>
                    <c:extLst>
                      <c:ext uri="{02D57815-91ED-43cb-92C2-25804820EDAC}">
                        <c15:formulaRef>
                          <c15:sqref>Sheet3!$A$1</c15:sqref>
                        </c15:formulaRef>
                      </c:ext>
                    </c:extLst>
                    <c:strCache>
                      <c:ptCount val="1"/>
                      <c:pt idx="0">
                        <c:v>Year</c:v>
                      </c:pt>
                    </c:strCache>
                  </c:strRef>
                </c:tx>
                <c:spPr>
                  <a:ln w="28575" cap="rnd">
                    <a:solidFill>
                      <a:schemeClr val="accent1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1"/>
                    </a:solidFill>
                    <a:ln w="9525">
                      <a:solidFill>
                        <a:schemeClr val="accent1"/>
                      </a:solidFill>
                    </a:ln>
                    <a:effectLst/>
                  </c:spPr>
                </c:marker>
                <c:cat>
                  <c:numRef>
                    <c:extLst>
                      <c:ext uri="{02D57815-91ED-43cb-92C2-25804820EDAC}">
                        <c15:formulaRef>
                          <c15:sqref>Sheet3!$A$2:$A$11</c15:sqref>
                        </c15:formulaRef>
                      </c:ext>
                    </c:extLst>
                    <c:numCache>
                      <c:formatCode>General</c:formatCode>
                      <c:ptCount val="10"/>
                      <c:pt idx="0">
                        <c:v>2015</c:v>
                      </c:pt>
                      <c:pt idx="1">
                        <c:v>2016</c:v>
                      </c:pt>
                      <c:pt idx="2">
                        <c:v>2017</c:v>
                      </c:pt>
                      <c:pt idx="3">
                        <c:v>2018</c:v>
                      </c:pt>
                      <c:pt idx="4">
                        <c:v>2019</c:v>
                      </c:pt>
                      <c:pt idx="5">
                        <c:v>2020</c:v>
                      </c:pt>
                      <c:pt idx="6">
                        <c:v>2021</c:v>
                      </c:pt>
                      <c:pt idx="7">
                        <c:v>2022</c:v>
                      </c:pt>
                      <c:pt idx="8">
                        <c:v>2023</c:v>
                      </c:pt>
                      <c:pt idx="9">
                        <c:v>2024</c:v>
                      </c:pt>
                    </c:numCache>
                  </c:numRef>
                </c:cat>
                <c:val>
                  <c:numRef>
                    <c:extLst>
                      <c:ext uri="{02D57815-91ED-43cb-92C2-25804820EDAC}">
                        <c15:formulaRef>
                          <c15:sqref>Sheet3!$A$2:$A$11</c15:sqref>
                        </c15:formulaRef>
                      </c:ext>
                    </c:extLst>
                    <c:numCache>
                      <c:formatCode>General</c:formatCode>
                      <c:ptCount val="10"/>
                      <c:pt idx="0">
                        <c:v>2015</c:v>
                      </c:pt>
                      <c:pt idx="1">
                        <c:v>2016</c:v>
                      </c:pt>
                      <c:pt idx="2">
                        <c:v>2017</c:v>
                      </c:pt>
                      <c:pt idx="3">
                        <c:v>2018</c:v>
                      </c:pt>
                      <c:pt idx="4">
                        <c:v>2019</c:v>
                      </c:pt>
                      <c:pt idx="5">
                        <c:v>2020</c:v>
                      </c:pt>
                      <c:pt idx="6">
                        <c:v>2021</c:v>
                      </c:pt>
                      <c:pt idx="7">
                        <c:v>2022</c:v>
                      </c:pt>
                      <c:pt idx="8">
                        <c:v>2023</c:v>
                      </c:pt>
                      <c:pt idx="9">
                        <c:v>2024</c:v>
                      </c:pt>
                    </c:numCache>
                  </c:numRef>
                </c:val>
                <c:smooth val="0"/>
                <c:extLst>
                  <c:ext xmlns:c16="http://schemas.microsoft.com/office/drawing/2014/chart" uri="{C3380CC4-5D6E-409C-BE32-E72D297353CC}">
                    <c16:uniqueId val="{00000005-CFAD-4A0F-9656-AA90D53181ED}"/>
                  </c:ext>
                </c:extLst>
              </c15:ser>
            </c15:filteredLineSeries>
          </c:ext>
        </c:extLst>
      </c:lineChart>
      <c:catAx>
        <c:axId val="1963062447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/>
                  <a:t>Year</a:t>
                </a:r>
              </a:p>
            </c:rich>
          </c:tx>
          <c:layout>
            <c:manualLayout>
              <c:xMode val="edge"/>
              <c:yMode val="edge"/>
              <c:x val="0.50235864207324032"/>
              <c:y val="0.8831323331156498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he-IL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he-IL"/>
          </a:p>
        </c:txPr>
        <c:crossAx val="1963042287"/>
        <c:crosses val="autoZero"/>
        <c:auto val="1"/>
        <c:lblAlgn val="ctr"/>
        <c:lblOffset val="100"/>
        <c:noMultiLvlLbl val="0"/>
      </c:catAx>
      <c:valAx>
        <c:axId val="1963042287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800" b="1" dirty="0"/>
                  <a:t>% of Patients Receiving Treatment</a:t>
                </a:r>
              </a:p>
            </c:rich>
          </c:tx>
          <c:layout>
            <c:manualLayout>
              <c:xMode val="edge"/>
              <c:yMode val="edge"/>
              <c:x val="5.3682183003997026E-3"/>
              <c:y val="0.1785753794577771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he-IL"/>
            </a:p>
          </c:txPr>
        </c:title>
        <c:numFmt formatCode="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he-IL"/>
          </a:p>
        </c:txPr>
        <c:crossAx val="1963062447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51617072324061"/>
          <c:y val="0.94412649824228811"/>
          <c:w val="0.49676585535187801"/>
          <c:h val="5.587350175771192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he-IL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he-IL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fld id="{64F9BC76-8183-4722-93C5-32CDA81AF4C0}" type="datetimeFigureOut">
              <a:rPr lang="he-IL" smtClean="0"/>
              <a:t>ט'/אב/תשפ"ו</a:t>
            </a:fld>
            <a:endParaRPr lang="he-IL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he-IL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fld id="{930ECA89-A63F-4E0B-97B7-93E7C374AF8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500641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nline Resource</a:t>
            </a:r>
            <a:r>
              <a:rPr lang="en-US" dirty="0"/>
              <a:t> 1: Annual incidence of eosinophilic esophagitis (EoE) diagnoses from 2009 to 2023. The solid line represents the yearly number of diagnoses, while the dotted line indicates the linear trend. A significant upward trend was observed over time (R² = 0.7972, p &lt;0.0001)</a:t>
            </a:r>
            <a:endParaRPr lang="he-IL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30ECA89-A63F-4E0B-97B7-93E7C374AF85}" type="slidenum">
              <a:rPr lang="he-IL" smtClean="0"/>
              <a:t>1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64796578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algn="l" defTabSz="914400" rtl="0" eaLnBrk="1" latinLnBrk="0" hangingPunct="1"/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nline Resource</a:t>
            </a:r>
            <a:r>
              <a:rPr lang="en-US" sz="120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2: Starting in 2015, Hadassah Medical Center began managing a higher volume of patients (over 20 procedures annually). Therefore, this figure presents treatment strategies implemented during the past decade. </a:t>
            </a:r>
          </a:p>
          <a:p>
            <a:pPr marL="0" algn="l" defTabSz="914400" rtl="0" eaLnBrk="1" latinLnBrk="0" hangingPunct="1"/>
            <a:r>
              <a:rPr lang="en-US" sz="1200" b="1" kern="1200" dirty="0">
                <a:solidFill>
                  <a:schemeClr val="tx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+mn-lt"/>
                <a:ea typeface="+mn-ea"/>
                <a:cs typeface="+mn-cs"/>
              </a:rPr>
              <a:t>*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roton Pump Inhibitors</a:t>
            </a:r>
            <a:endParaRPr lang="en-US" sz="1200" b="1" kern="1200" dirty="0">
              <a:solidFill>
                <a:srgbClr val="FF000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+mn-lt"/>
              <a:ea typeface="+mn-ea"/>
              <a:cs typeface="+mn-cs"/>
            </a:endParaRPr>
          </a:p>
          <a:p>
            <a:pPr rtl="0"/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† Topical Corticosteroids</a:t>
            </a:r>
          </a:p>
          <a:p>
            <a:pPr rtl="0"/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‡ 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ystemic Corticosteroids</a:t>
            </a:r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30ECA89-A63F-4E0B-97B7-93E7C374AF85}" type="slidenum">
              <a:rPr lang="he-IL" smtClean="0"/>
              <a:t>2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8447201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F63A01-7BF0-E77C-F7D7-85EA446712D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A6A53C1-D08C-7C9C-ACB3-76562145EFD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he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632851-EC86-D2AA-B184-1C6DBB8F19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BDF95-BD10-4778-AADE-FA4431B4AF0A}" type="datetimeFigureOut">
              <a:rPr lang="he-IL" smtClean="0"/>
              <a:t>ט'/אב/תשפ"ו</a:t>
            </a:fld>
            <a:endParaRPr lang="he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B0447E-172C-5FAA-DBE4-633E60E007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7F3F49-22BD-15B7-8DAA-A4DD226984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3D274-CCF4-45E4-98B9-1340400AEB3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3510643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83EC4F-C788-ADE6-F25C-B728DA204D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E4D6388-FA19-3D57-C3C4-582A3C1E8D7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1EB04D-BDC0-3C29-F38C-13E30D5814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BDF95-BD10-4778-AADE-FA4431B4AF0A}" type="datetimeFigureOut">
              <a:rPr lang="he-IL" smtClean="0"/>
              <a:t>ט'/אב/תשפ"ו</a:t>
            </a:fld>
            <a:endParaRPr lang="he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159A6F2-236F-B760-9728-21DB2F634E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E6691B-4B2E-3364-C6C6-29FAE0CC83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3D274-CCF4-45E4-98B9-1340400AEB3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3311046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3ACB17A-BF4D-0DD8-470D-0C2369F341D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D6AE9E7-7546-9948-5DAA-0916B66B5B9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2BF478-3393-01B6-ED55-4D87AF6521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BDF95-BD10-4778-AADE-FA4431B4AF0A}" type="datetimeFigureOut">
              <a:rPr lang="he-IL" smtClean="0"/>
              <a:t>ט'/אב/תשפ"ו</a:t>
            </a:fld>
            <a:endParaRPr lang="he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E395A5-F8A4-5E42-67DA-F7A50E4E97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1C6363-CBDC-670B-AF50-A3D83D8BBF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3D274-CCF4-45E4-98B9-1340400AEB3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4579004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91A34B-41BC-24C6-43AB-63A939BCA8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BC1B0F1-BE67-55CB-FAA4-4D48AF73256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E6220FC-EF97-7400-2957-74D38D949D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BDF95-BD10-4778-AADE-FA4431B4AF0A}" type="datetimeFigureOut">
              <a:rPr lang="he-IL" smtClean="0"/>
              <a:t>ט'/אב/תשפ"ו</a:t>
            </a:fld>
            <a:endParaRPr lang="he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DB779E-7C37-30A8-7643-B9DF963A23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641FA9-25F7-215C-7D7C-1A60DBBC37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3D274-CCF4-45E4-98B9-1340400AEB3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1798142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D69FF8-0E24-9B50-DCC2-58C7B6F5FC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523BCED-71CB-5FC6-F6F9-77D2EEDBEF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24F47F-44DB-65A1-E4B3-019F36D033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BDF95-BD10-4778-AADE-FA4431B4AF0A}" type="datetimeFigureOut">
              <a:rPr lang="he-IL" smtClean="0"/>
              <a:t>ט'/אב/תשפ"ו</a:t>
            </a:fld>
            <a:endParaRPr lang="he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62CACD-F78D-B102-D1C1-E13153E951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71D414-73BD-9910-5E06-7FA82E3B1C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3D274-CCF4-45E4-98B9-1340400AEB3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397774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EFF6EC-BBEC-7B3E-B5C2-82365A3E35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F9FCE1F-6B71-A44F-26AD-2575CF1A17C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24E47C5-C511-B799-3645-FD5043F92DB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1D63889-884A-4414-B6C4-8BA4491A14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BDF95-BD10-4778-AADE-FA4431B4AF0A}" type="datetimeFigureOut">
              <a:rPr lang="he-IL" smtClean="0"/>
              <a:t>ט'/אב/תשפ"ו</a:t>
            </a:fld>
            <a:endParaRPr lang="he-I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248D913-B9DC-9E41-1746-4E2130CBF8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BCB329A-9179-1BAF-62AF-2AE6B7AF75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3D274-CCF4-45E4-98B9-1340400AEB3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196943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CA09BF-45E7-CC55-7738-4E124733A4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46C2045-BA15-93CA-BD41-A55E8DD6BC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B343901-CA97-628E-86DE-3951F5DB027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D0180A4-51F1-0DF3-D7B2-112CEE9D1B0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5FC6C82-EDBC-7295-AC09-B3C670DCDFF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F333C71-F481-49A3-8A72-05C80EB5AC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BDF95-BD10-4778-AADE-FA4431B4AF0A}" type="datetimeFigureOut">
              <a:rPr lang="he-IL" smtClean="0"/>
              <a:t>ט'/אב/תשפ"ו</a:t>
            </a:fld>
            <a:endParaRPr lang="he-IL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B46F73F-E830-565F-3F2C-9EB43798A9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AD5DD06-5C83-F04A-64EA-0D54B751AA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3D274-CCF4-45E4-98B9-1340400AEB3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4451152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E0E366-81C1-9FC6-F735-DD93B782BC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4915B66-7820-1B85-4AA2-0AB8E08BC2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BDF95-BD10-4778-AADE-FA4431B4AF0A}" type="datetimeFigureOut">
              <a:rPr lang="he-IL" smtClean="0"/>
              <a:t>ט'/אב/תשפ"ו</a:t>
            </a:fld>
            <a:endParaRPr lang="he-IL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E9A8432-459D-1ECC-BE73-C4C3451A03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4C15056-ABA7-9931-E5F3-7DFEFAF916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3D274-CCF4-45E4-98B9-1340400AEB3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854137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D0D00C9-3EA9-DF8A-9B67-BFEEBF02B0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BDF95-BD10-4778-AADE-FA4431B4AF0A}" type="datetimeFigureOut">
              <a:rPr lang="he-IL" smtClean="0"/>
              <a:t>ט'/אב/תשפ"ו</a:t>
            </a:fld>
            <a:endParaRPr lang="he-IL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CDFBFAF-39ED-2BCE-6917-D444945831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74C2DAE-3C4F-929B-A1CB-9DDDE226EF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3D274-CCF4-45E4-98B9-1340400AEB3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3341960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6BFF0F-D490-A4C9-EA04-5253AB6C39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6FAAB13-314B-6078-C51C-C3E00D31100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B9D4083-3DB5-BE28-2475-761E941748B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468AB10-AF82-7740-00C3-7387ED6D8F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BDF95-BD10-4778-AADE-FA4431B4AF0A}" type="datetimeFigureOut">
              <a:rPr lang="he-IL" smtClean="0"/>
              <a:t>ט'/אב/תשפ"ו</a:t>
            </a:fld>
            <a:endParaRPr lang="he-I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A60F0B1-DF36-1FC8-E777-EAE03222D0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71B48B9-E01E-98EC-0068-F4B354580F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3D274-CCF4-45E4-98B9-1340400AEB3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0735355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47E8C4-1AEE-3777-FF5A-E50178B95B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2F14CB2-C6EF-EC55-E94B-205D1CB4910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BC3CA47-7AA1-120C-9817-8F4D53A3B46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82C7C54-D79D-5BC9-0A6E-2D0A7926BE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BDF95-BD10-4778-AADE-FA4431B4AF0A}" type="datetimeFigureOut">
              <a:rPr lang="he-IL" smtClean="0"/>
              <a:t>ט'/אב/תשפ"ו</a:t>
            </a:fld>
            <a:endParaRPr lang="he-I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837B182-15A6-9E8A-A3DA-13C6882BBD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877E84D-666F-A864-80A7-7F1088C3F6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3D274-CCF4-45E4-98B9-1340400AEB3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5923262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DB13E3C-42BD-92B6-88F8-CF78FFA9C0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BF4F6EE-C39F-7EE8-3202-14262B5658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ABF7A3-AE01-D0CA-410B-09EF8C40D87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54BDF95-BD10-4778-AADE-FA4431B4AF0A}" type="datetimeFigureOut">
              <a:rPr lang="he-IL" smtClean="0"/>
              <a:t>ט'/אב/תשפ"ו</a:t>
            </a:fld>
            <a:endParaRPr lang="he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CB792D-C60C-4FD2-304D-83367927B3F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51A4D6-B25E-85F4-F255-6A60D2C4A08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373D274-CCF4-45E4-98B9-1340400AEB3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8853875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87464D01-6806-9B8A-5DC7-2AD9017AE07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48273685"/>
              </p:ext>
            </p:extLst>
          </p:nvPr>
        </p:nvGraphicFramePr>
        <p:xfrm>
          <a:off x="2259805" y="1271752"/>
          <a:ext cx="7672389" cy="41908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31248608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8C4C000E-493F-5455-8A19-39E46BB5B06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33905151"/>
              </p:ext>
            </p:extLst>
          </p:nvPr>
        </p:nvGraphicFramePr>
        <p:xfrm>
          <a:off x="1446772" y="564931"/>
          <a:ext cx="9051234" cy="57281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578018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128</Words>
  <Application>Microsoft Office PowerPoint</Application>
  <PresentationFormat>Widescreen</PresentationFormat>
  <Paragraphs>13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שריה גרינברגר</dc:creator>
  <cp:lastModifiedBy>Sraya Greenberger</cp:lastModifiedBy>
  <cp:revision>8</cp:revision>
  <dcterms:created xsi:type="dcterms:W3CDTF">2026-01-05T17:59:42Z</dcterms:created>
  <dcterms:modified xsi:type="dcterms:W3CDTF">2026-07-23T13:42:08Z</dcterms:modified>
</cp:coreProperties>
</file>